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13679488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02" userDrawn="1">
          <p15:clr>
            <a:srgbClr val="A4A3A4"/>
          </p15:clr>
        </p15:guide>
        <p15:guide id="2" pos="28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951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1480" y="192"/>
      </p:cViewPr>
      <p:guideLst>
        <p:guide orient="horz" pos="1202"/>
        <p:guide pos="28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5962" y="1472842"/>
            <a:ext cx="11627565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09936" y="4726842"/>
            <a:ext cx="10259616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3559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9959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789384" y="479142"/>
            <a:ext cx="2949640" cy="7626692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0466" y="479142"/>
            <a:ext cx="8677925" cy="7626692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9143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6090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3341" y="2243638"/>
            <a:ext cx="11798558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3341" y="6022610"/>
            <a:ext cx="11798558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4063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0465" y="2395710"/>
            <a:ext cx="5813782" cy="571012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5241" y="2395710"/>
            <a:ext cx="5813782" cy="571012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4934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479144"/>
            <a:ext cx="11798558" cy="173949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248" y="2206137"/>
            <a:ext cx="5787064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2248" y="3287331"/>
            <a:ext cx="5787064" cy="483516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25242" y="2206137"/>
            <a:ext cx="5815564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25242" y="3287331"/>
            <a:ext cx="5815564" cy="483516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022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344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851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599969"/>
            <a:ext cx="4411991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15564" y="1295769"/>
            <a:ext cx="6925241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2247" y="2699862"/>
            <a:ext cx="4411991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6604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599969"/>
            <a:ext cx="4411991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15564" y="1295769"/>
            <a:ext cx="6925241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2247" y="2699862"/>
            <a:ext cx="4411991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882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0465" y="479144"/>
            <a:ext cx="11798558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0465" y="2395710"/>
            <a:ext cx="11798558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0465" y="8341240"/>
            <a:ext cx="307788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E720C-7AFA-4EA4-9367-D6CEA50B6E83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31331" y="8341240"/>
            <a:ext cx="461682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61138" y="8341240"/>
            <a:ext cx="307788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519CFD-637B-4F74-8870-90ADD7F3277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667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922463" y="2305787"/>
            <a:ext cx="4493237" cy="1437453"/>
            <a:chOff x="6882645" y="333861"/>
            <a:chExt cx="4493237" cy="1437453"/>
          </a:xfrm>
        </p:grpSpPr>
        <p:sp>
          <p:nvSpPr>
            <p:cNvPr id="3" name="Rechteck 2"/>
            <p:cNvSpPr/>
            <p:nvPr/>
          </p:nvSpPr>
          <p:spPr>
            <a:xfrm>
              <a:off x="10141861" y="1261110"/>
              <a:ext cx="181234" cy="10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6882645" y="708587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3</a:t>
              </a: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10404141" y="708585"/>
              <a:ext cx="9717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cryptic exon 3</a:t>
              </a: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6882645" y="992806"/>
              <a:ext cx="1404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dsDNA oligo (123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7" name="Gruppieren 6"/>
            <p:cNvGrpSpPr/>
            <p:nvPr/>
          </p:nvGrpSpPr>
          <p:grpSpPr>
            <a:xfrm>
              <a:off x="6970393" y="592867"/>
              <a:ext cx="4320000" cy="102575"/>
              <a:chOff x="6970393" y="592867"/>
              <a:chExt cx="4428000" cy="102575"/>
            </a:xfrm>
          </p:grpSpPr>
          <p:cxnSp>
            <p:nvCxnSpPr>
              <p:cNvPr id="10" name="Gerader Verbinder 9"/>
              <p:cNvCxnSpPr/>
              <p:nvPr/>
            </p:nvCxnSpPr>
            <p:spPr>
              <a:xfrm>
                <a:off x="6970393" y="695442"/>
                <a:ext cx="1476000" cy="0"/>
              </a:xfrm>
              <a:prstGeom prst="line">
                <a:avLst/>
              </a:prstGeom>
              <a:ln w="76200">
                <a:solidFill>
                  <a:schemeClr val="accent3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Gerader Verbinder 10"/>
              <p:cNvCxnSpPr/>
              <p:nvPr/>
            </p:nvCxnSpPr>
            <p:spPr>
              <a:xfrm>
                <a:off x="8446393" y="695442"/>
                <a:ext cx="2952000" cy="0"/>
              </a:xfrm>
              <a:prstGeom prst="line">
                <a:avLst/>
              </a:prstGeom>
              <a:ln w="76200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Gerade Verbindung mit Pfeil 11"/>
              <p:cNvCxnSpPr/>
              <p:nvPr/>
            </p:nvCxnSpPr>
            <p:spPr>
              <a:xfrm flipV="1">
                <a:off x="7906393" y="592867"/>
                <a:ext cx="828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Gerade Verbindung mit Pfeil 12"/>
              <p:cNvCxnSpPr/>
              <p:nvPr/>
            </p:nvCxnSpPr>
            <p:spPr>
              <a:xfrm flipV="1">
                <a:off x="9022393" y="592867"/>
                <a:ext cx="612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Gerade Verbindung mit Pfeil 13"/>
              <p:cNvCxnSpPr/>
              <p:nvPr/>
            </p:nvCxnSpPr>
            <p:spPr>
              <a:xfrm flipV="1">
                <a:off x="9670393" y="592867"/>
                <a:ext cx="792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Rechteck 7"/>
            <p:cNvSpPr/>
            <p:nvPr/>
          </p:nvSpPr>
          <p:spPr>
            <a:xfrm>
              <a:off x="6882646" y="1194233"/>
              <a:ext cx="4493236" cy="577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5’‑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CGTCTTCGGAAATGTTATGAAGC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GGATGACTCTGGGA</a:t>
              </a:r>
              <a:r>
                <a:rPr lang="en-US" sz="1050" b="1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AAATTC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GGGTTGG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AATTGCAAGCATCTCA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050" u="sng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ATGACCAGACCCTGAAGAAAG</a:t>
              </a:r>
              <a:r>
                <a:rPr lang="en-US" sz="1050" dirty="0"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CTGACTTGCCTCATTCAAAATGAGG‑3’</a:t>
              </a: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6882645" y="333861"/>
              <a:ext cx="13612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mplicon size: 71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5" name="Objekt 14">
            <a:extLst>
              <a:ext uri="{FF2B5EF4-FFF2-40B4-BE49-F238E27FC236}">
                <a16:creationId xmlns:a16="http://schemas.microsoft.com/office/drawing/2014/main" id="{0A4C3D75-73BE-46A7-9BAF-BF975EDAF4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5450097"/>
              </p:ext>
            </p:extLst>
          </p:nvPr>
        </p:nvGraphicFramePr>
        <p:xfrm>
          <a:off x="5467774" y="356481"/>
          <a:ext cx="2729610" cy="375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33880" imgH="5543491" progId="Prism8.Document">
                  <p:embed/>
                </p:oleObj>
              </mc:Choice>
              <mc:Fallback>
                <p:oleObj name="Prism 8" r:id="rId2" imgW="4033880" imgH="5543491" progId="Prism8.Document">
                  <p:embed/>
                  <p:pic>
                    <p:nvPicPr>
                      <p:cNvPr id="33" name="Objekt 32">
                        <a:extLst>
                          <a:ext uri="{FF2B5EF4-FFF2-40B4-BE49-F238E27FC236}">
                            <a16:creationId xmlns:a16="http://schemas.microsoft.com/office/drawing/2014/main" id="{0A4C3D75-73BE-46A7-9BAF-BF975EDAF4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467774" y="356481"/>
                        <a:ext cx="2729610" cy="375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feld 16">
            <a:extLst>
              <a:ext uri="{FF2B5EF4-FFF2-40B4-BE49-F238E27FC236}">
                <a16:creationId xmlns:a16="http://schemas.microsoft.com/office/drawing/2014/main" id="{AEC75F64-C29F-4115-9C47-53D7692F9B81}"/>
              </a:ext>
            </a:extLst>
          </p:cNvPr>
          <p:cNvSpPr txBox="1"/>
          <p:nvPr/>
        </p:nvSpPr>
        <p:spPr>
          <a:xfrm rot="16200000">
            <a:off x="106872" y="2857129"/>
            <a:ext cx="13414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R-V7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4D336D59-0F38-4747-B7E7-918F83B652CF}"/>
              </a:ext>
            </a:extLst>
          </p:cNvPr>
          <p:cNvSpPr txBox="1"/>
          <p:nvPr/>
        </p:nvSpPr>
        <p:spPr>
          <a:xfrm rot="16200000">
            <a:off x="99016" y="1213902"/>
            <a:ext cx="1357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KLK3-PSA</a:t>
            </a:r>
          </a:p>
        </p:txBody>
      </p:sp>
      <p:grpSp>
        <p:nvGrpSpPr>
          <p:cNvPr id="19" name="Gruppieren 18"/>
          <p:cNvGrpSpPr/>
          <p:nvPr/>
        </p:nvGrpSpPr>
        <p:grpSpPr>
          <a:xfrm>
            <a:off x="915968" y="652879"/>
            <a:ext cx="4514579" cy="1469385"/>
            <a:chOff x="572875" y="307535"/>
            <a:chExt cx="4514579" cy="1469385"/>
          </a:xfrm>
        </p:grpSpPr>
        <p:sp>
          <p:nvSpPr>
            <p:cNvPr id="20" name="Rechteck 19"/>
            <p:cNvSpPr/>
            <p:nvPr/>
          </p:nvSpPr>
          <p:spPr>
            <a:xfrm>
              <a:off x="572876" y="1199839"/>
              <a:ext cx="4506119" cy="577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5’‑GGCAGTCTGCGGCGGTGTTCTGGTGCACCCCCAGTGGGTCCTCACAGCTGCCCACTGCATCAGGA</a:t>
              </a:r>
              <a:r>
                <a:rPr lang="en-US" sz="1050" b="1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C</a:t>
              </a:r>
              <a:r>
                <a:rPr lang="en-US" sz="1050" dirty="0"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AAAGCGTGATCTTGCTGGGTCGGCACAGCCTGTTTCATCCTGAAGACACAGGCCAGGTATTTCA‑3’</a:t>
              </a:r>
              <a:endParaRPr lang="de-DE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" name="Gruppieren 20"/>
            <p:cNvGrpSpPr/>
            <p:nvPr/>
          </p:nvGrpSpPr>
          <p:grpSpPr>
            <a:xfrm>
              <a:off x="664272" y="665744"/>
              <a:ext cx="4309840" cy="0"/>
              <a:chOff x="5301765" y="1652262"/>
              <a:chExt cx="4309840" cy="0"/>
            </a:xfrm>
          </p:grpSpPr>
          <p:cxnSp>
            <p:nvCxnSpPr>
              <p:cNvPr id="27" name="Gerader Verbinder 26"/>
              <p:cNvCxnSpPr/>
              <p:nvPr/>
            </p:nvCxnSpPr>
            <p:spPr>
              <a:xfrm>
                <a:off x="5301765" y="1652262"/>
                <a:ext cx="2160000" cy="0"/>
              </a:xfrm>
              <a:prstGeom prst="line">
                <a:avLst/>
              </a:prstGeom>
              <a:ln w="762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Gerader Verbinder 27"/>
              <p:cNvCxnSpPr/>
              <p:nvPr/>
            </p:nvCxnSpPr>
            <p:spPr>
              <a:xfrm>
                <a:off x="7451605" y="1652262"/>
                <a:ext cx="2160000" cy="0"/>
              </a:xfrm>
              <a:prstGeom prst="line">
                <a:avLst/>
              </a:prstGeom>
              <a:ln w="76200">
                <a:solidFill>
                  <a:schemeClr val="accent3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Textfeld 21"/>
            <p:cNvSpPr txBox="1"/>
            <p:nvPr/>
          </p:nvSpPr>
          <p:spPr>
            <a:xfrm>
              <a:off x="572875" y="670095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2</a:t>
              </a: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4521273" y="670093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exon 3</a:t>
              </a: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572875" y="1005836"/>
              <a:ext cx="14045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dsDNA oligo (132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584706" y="307535"/>
              <a:ext cx="30091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mplicon size: 64 </a:t>
              </a:r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; targeted region confidential</a:t>
              </a:r>
            </a:p>
          </p:txBody>
        </p:sp>
        <p:cxnSp>
          <p:nvCxnSpPr>
            <p:cNvPr id="26" name="Gerader Verbinder 25"/>
            <p:cNvCxnSpPr/>
            <p:nvPr/>
          </p:nvCxnSpPr>
          <p:spPr>
            <a:xfrm>
              <a:off x="1257718" y="565656"/>
              <a:ext cx="3132000" cy="0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Textfeld 28">
            <a:extLst>
              <a:ext uri="{FF2B5EF4-FFF2-40B4-BE49-F238E27FC236}">
                <a16:creationId xmlns:a16="http://schemas.microsoft.com/office/drawing/2014/main" id="{747064CC-D018-43AE-9BE6-16383934F835}"/>
              </a:ext>
            </a:extLst>
          </p:cNvPr>
          <p:cNvSpPr txBox="1"/>
          <p:nvPr/>
        </p:nvSpPr>
        <p:spPr>
          <a:xfrm>
            <a:off x="460727" y="409233"/>
            <a:ext cx="289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648EB31A-737B-4CBF-9A62-0F090FBD9CAF}"/>
              </a:ext>
            </a:extLst>
          </p:cNvPr>
          <p:cNvSpPr txBox="1"/>
          <p:nvPr/>
        </p:nvSpPr>
        <p:spPr>
          <a:xfrm>
            <a:off x="5434322" y="409233"/>
            <a:ext cx="289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sp>
        <p:nvSpPr>
          <p:cNvPr id="31" name="Rechteck 30"/>
          <p:cNvSpPr/>
          <p:nvPr/>
        </p:nvSpPr>
        <p:spPr>
          <a:xfrm>
            <a:off x="5966736" y="1562767"/>
            <a:ext cx="119601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 sz="1000" b="0" i="0" u="none" strike="noStrike" kern="1200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900" dirty="0"/>
              <a:t>y = -3.98x + 44.86</a:t>
            </a:r>
            <a:br>
              <a:rPr lang="en-US" sz="900" dirty="0"/>
            </a:br>
            <a:r>
              <a:rPr lang="en-US" sz="900" dirty="0"/>
              <a:t>R² = 0.9965</a:t>
            </a:r>
          </a:p>
        </p:txBody>
      </p:sp>
      <p:sp>
        <p:nvSpPr>
          <p:cNvPr id="32" name="Rechteck 31"/>
          <p:cNvSpPr/>
          <p:nvPr/>
        </p:nvSpPr>
        <p:spPr>
          <a:xfrm>
            <a:off x="5969989" y="3226366"/>
            <a:ext cx="144942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/>
              <a:t>y = -3.65x + 40.09</a:t>
            </a:r>
            <a:br>
              <a:rPr lang="en-US" sz="900" dirty="0"/>
            </a:br>
            <a:r>
              <a:rPr lang="en-US" sz="900" dirty="0"/>
              <a:t>R² = 0.9998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3623D480-E098-4B1E-8C40-5995078FB790}"/>
              </a:ext>
            </a:extLst>
          </p:cNvPr>
          <p:cNvSpPr txBox="1"/>
          <p:nvPr/>
        </p:nvSpPr>
        <p:spPr>
          <a:xfrm>
            <a:off x="305019" y="92174"/>
            <a:ext cx="1059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S2:</a:t>
            </a:r>
          </a:p>
        </p:txBody>
      </p:sp>
    </p:spTree>
    <p:extLst>
      <p:ext uri="{BB962C8B-B14F-4D97-AF65-F5344CB8AC3E}">
        <p14:creationId xmlns:p14="http://schemas.microsoft.com/office/powerpoint/2010/main" val="2304296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4</Words>
  <Application>Microsoft Macintosh PowerPoint</Application>
  <PresentationFormat>Benutzerdefiniert</PresentationFormat>
  <Paragraphs>17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Office</vt:lpstr>
      <vt:lpstr>Prism 8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üstmann, Neele Elisabeth</dc:creator>
  <cp:lastModifiedBy>Christof Bernemann</cp:lastModifiedBy>
  <cp:revision>18</cp:revision>
  <dcterms:created xsi:type="dcterms:W3CDTF">2022-05-24T09:36:39Z</dcterms:created>
  <dcterms:modified xsi:type="dcterms:W3CDTF">2022-06-04T18:03:09Z</dcterms:modified>
</cp:coreProperties>
</file>